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72" r:id="rId4"/>
    <p:sldId id="258" r:id="rId5"/>
    <p:sldId id="259" r:id="rId6"/>
    <p:sldId id="273" r:id="rId7"/>
    <p:sldId id="260" r:id="rId8"/>
    <p:sldId id="261" r:id="rId9"/>
    <p:sldId id="274" r:id="rId10"/>
    <p:sldId id="262" r:id="rId11"/>
    <p:sldId id="263" r:id="rId12"/>
    <p:sldId id="264" r:id="rId13"/>
    <p:sldId id="265" r:id="rId14"/>
    <p:sldId id="275" r:id="rId15"/>
    <p:sldId id="266" r:id="rId16"/>
    <p:sldId id="276" r:id="rId17"/>
    <p:sldId id="277" r:id="rId18"/>
    <p:sldId id="267" r:id="rId19"/>
    <p:sldId id="278" r:id="rId20"/>
    <p:sldId id="268" r:id="rId21"/>
    <p:sldId id="269" r:id="rId22"/>
    <p:sldId id="270" r:id="rId23"/>
    <p:sldId id="280" r:id="rId24"/>
    <p:sldId id="279" r:id="rId25"/>
    <p:sldId id="271" r:id="rId2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677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AF00162-EC66-BD29-20FA-00F1DBB9EF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8B3DD71-B9E3-FD70-8982-76C663B7A8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72D993-C4E9-38D6-A694-AF6D5C75F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609012B-28F5-3E54-2D00-5ACD3DFC6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89A5BB0-B8F2-78F3-F691-E0E141C55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4725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9ADE119-33ED-4BB8-87B7-A51EE87EA3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F5BC083-52E8-6184-948D-CCA3F188E7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230B660-0D04-5500-3845-0CD68E93C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6A72081-6CEE-57CB-FF28-9C8BDAAD6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CD00907-4F93-978D-EBB7-5D318569D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4226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4699E21-C2F5-74B3-B202-E217726C4D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62B50B8-AA65-6F3D-CB44-083FD98120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6A5F90E-4FF2-EF7B-9E62-542F87468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D025554-28A4-3318-7C86-C2E1132B0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10DAB4A-E416-4238-4AD9-AB1FA7A12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7968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FB30970-2463-0EEC-0BBA-1B2A172FD3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A8F51A8-00EF-90A4-13A6-36FBC59BF7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4876DB8-DA98-3C27-9748-BA7D408B5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C6D737E-776D-0BC8-41DE-802A54A0C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832979F-8579-644E-969F-1BB62D3C7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7110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DFDBC1A-25E2-1347-461D-1DC371467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83117D5-5177-209D-5A26-E64794BC12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DC615DF-454B-6B9A-753E-5D936FB17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889ED3C-1616-D0AD-DD28-54D9DB62C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370B795-9ED3-42EA-12FD-C9EBE4267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6623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4D2322C-5972-6A4B-BD2A-14F69D3B7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C9C4878-E1B7-447C-65EF-47A193F986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B2F4C99-E7CD-8792-019C-4A70740A06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DCD5CA7-11B7-6982-B1A7-C8C4B1713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20FFF50-C5E6-34AD-F59A-F2212BB92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2273A45-57CE-AD51-420F-7802192D5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5994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BAFC35E-B08F-A2F1-4D5D-8DE6CFD1CF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FC8AD13-D4C8-5937-2CD2-6C8715E98B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A4646FF-3FF6-BFE2-2717-28DF81DB12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B862C035-899B-F6F9-CE4B-CB2F5BFB4E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7603081-AE51-FC54-F4AB-D17EFB9FC3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5168475-299C-CDC6-4449-A7B962E6D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57CB255-EABC-E0FD-BAA0-CAB20F103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1451746-7652-00F0-F652-42C6F0A4C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806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C388F2-757D-408B-7D69-8D2E54F3B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572B704-99EF-FA8C-7792-390A5939B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6CA26C2-6268-5E74-916D-96FC5206B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D727E7E-488D-0161-5F8C-988E8A626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321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BC939C2-6AAC-08C0-834B-A2AE6C397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28788433-439D-9F15-B8AE-AF1353259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D4245B86-826A-FF4C-58C9-A7F9A7713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6876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B4A520F-3132-5470-F7A6-EED6116C46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80D6A20-5436-7809-860D-077950DD9C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FAF113C-8F6B-C210-2ADF-B0C8C0B1C3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0907EAB-C4FA-3F74-BAC4-16EF8BEFA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80987B2-BF90-A761-57B8-1888A4A14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6A6FDCC-956C-89CC-F988-AF882164D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5958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8D67B14-5F46-4D9B-F200-F313AA5D71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061F9AE-6D94-F113-7C3F-3BA7A789DB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8196EE4-0852-C15F-A454-3BC8F7C45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8EBE763-58E6-29F7-2D73-69076E72D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8C92189-8687-C008-0E84-F518FBA8C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465D899-3E12-9D12-4A22-443B42459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0890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9368990-FC7D-5882-1572-30B625197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C4D46F9-E25D-98CB-2F85-FEA5297ADB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134CABC-CE4C-C18F-9741-4B19D88B3C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8F6D6B-9AFE-4333-86FE-E02CF3B4E194}" type="datetimeFigureOut">
              <a:rPr lang="ko-KR" altLang="en-US" smtClean="0"/>
              <a:t>2025-10-03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18D7D72-E98C-91A7-45F8-715BED9D51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4B49EBA-9482-D754-9A90-50D68F6789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6DDFA70-8ED2-430F-900F-67F3D3EC3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4024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8.tiff"/><Relationship Id="rId4" Type="http://schemas.openxmlformats.org/officeDocument/2006/relationships/image" Target="../media/image27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2.tiff"/><Relationship Id="rId4" Type="http://schemas.openxmlformats.org/officeDocument/2006/relationships/image" Target="../media/image31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6.tiff"/><Relationship Id="rId4" Type="http://schemas.openxmlformats.org/officeDocument/2006/relationships/image" Target="../media/image35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9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f"/><Relationship Id="rId2" Type="http://schemas.openxmlformats.org/officeDocument/2006/relationships/image" Target="../media/image40.tif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f"/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4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tiff"/><Relationship Id="rId2" Type="http://schemas.openxmlformats.org/officeDocument/2006/relationships/image" Target="../media/image47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9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tiff"/><Relationship Id="rId2" Type="http://schemas.openxmlformats.org/officeDocument/2006/relationships/image" Target="../media/image50.tiff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tiff"/><Relationship Id="rId2" Type="http://schemas.openxmlformats.org/officeDocument/2006/relationships/image" Target="../media/image5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4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tif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tiff"/><Relationship Id="rId2" Type="http://schemas.openxmlformats.org/officeDocument/2006/relationships/image" Target="../media/image55.tiff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tiff"/><Relationship Id="rId2" Type="http://schemas.openxmlformats.org/officeDocument/2006/relationships/image" Target="../media/image57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0.tiff"/><Relationship Id="rId4" Type="http://schemas.openxmlformats.org/officeDocument/2006/relationships/image" Target="../media/image59.tif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tiff"/><Relationship Id="rId2" Type="http://schemas.openxmlformats.org/officeDocument/2006/relationships/image" Target="../media/image6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3.tif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tiff"/><Relationship Id="rId2" Type="http://schemas.openxmlformats.org/officeDocument/2006/relationships/image" Target="../media/image64.tiff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tiff"/><Relationship Id="rId2" Type="http://schemas.openxmlformats.org/officeDocument/2006/relationships/image" Target="../media/image66.tiff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tiff"/><Relationship Id="rId2" Type="http://schemas.openxmlformats.org/officeDocument/2006/relationships/image" Target="../media/image68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7DF6E6BB-A8FF-C5B2-5F5D-906C04A7C4DE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6746" y="1298044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D92456E-F8C4-61C0-C1F4-9AB2B0A710AE}"/>
              </a:ext>
            </a:extLst>
          </p:cNvPr>
          <p:cNvSpPr txBox="1"/>
          <p:nvPr/>
        </p:nvSpPr>
        <p:spPr>
          <a:xfrm>
            <a:off x="2376908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G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0AD5C22B-BE72-E5F6-898A-E8ED443C8D9F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4216" y="1361419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08D195D-FDBB-F709-1663-A11FB28E0CD2}"/>
              </a:ext>
            </a:extLst>
          </p:cNvPr>
          <p:cNvSpPr txBox="1"/>
          <p:nvPr/>
        </p:nvSpPr>
        <p:spPr>
          <a:xfrm>
            <a:off x="7974595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G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</a:p>
        </p:txBody>
      </p:sp>
    </p:spTree>
    <p:extLst>
      <p:ext uri="{BB962C8B-B14F-4D97-AF65-F5344CB8AC3E}">
        <p14:creationId xmlns:p14="http://schemas.microsoft.com/office/powerpoint/2010/main" val="7110036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51CFC7E-42C6-D770-63B0-D93FC90BF8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D6650D6-B54D-6546-FA73-B8585281DC8A}"/>
              </a:ext>
            </a:extLst>
          </p:cNvPr>
          <p:cNvSpPr txBox="1"/>
          <p:nvPr/>
        </p:nvSpPr>
        <p:spPr>
          <a:xfrm>
            <a:off x="720886" y="341872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E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983842E-D1F7-2F33-0EE4-B32BF0096410}"/>
              </a:ext>
            </a:extLst>
          </p:cNvPr>
          <p:cNvSpPr txBox="1"/>
          <p:nvPr/>
        </p:nvSpPr>
        <p:spPr>
          <a:xfrm>
            <a:off x="6871606" y="341872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E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 (S386)</a:t>
            </a:r>
          </a:p>
        </p:txBody>
      </p:sp>
      <p:pic>
        <p:nvPicPr>
          <p:cNvPr id="3" name="그림 2" descr="디자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4D690297-C46B-9AE8-613E-96DC05F10E1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59258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7" name="그림 6" descr="텍스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69446692-F608-092C-A205-2CDA83F99D3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2050" y="1359258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1" name="그림 10" descr="측정 스틱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D175E283-0A11-02E5-DB4B-5D79D0BC0415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6423" y="1359258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C7BF613-03CD-7CC0-60E9-EE987212A25D}"/>
              </a:ext>
            </a:extLst>
          </p:cNvPr>
          <p:cNvSpPr txBox="1"/>
          <p:nvPr/>
        </p:nvSpPr>
        <p:spPr>
          <a:xfrm>
            <a:off x="3691277" y="341872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E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 (S396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983842E-D1F7-2F33-0EE4-B32BF0096410}"/>
              </a:ext>
            </a:extLst>
          </p:cNvPr>
          <p:cNvSpPr txBox="1"/>
          <p:nvPr/>
        </p:nvSpPr>
        <p:spPr>
          <a:xfrm>
            <a:off x="9930516" y="341871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E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0960" y="1359258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1472931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0A050E-E78F-1160-9372-6A8482CBE0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1FA20DA-4097-D581-35B4-54024B6BAF4F}"/>
              </a:ext>
            </a:extLst>
          </p:cNvPr>
          <p:cNvSpPr txBox="1"/>
          <p:nvPr/>
        </p:nvSpPr>
        <p:spPr>
          <a:xfrm>
            <a:off x="716359" y="285602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7DE20CC-CFA0-2176-FB13-FC67325D01A8}"/>
              </a:ext>
            </a:extLst>
          </p:cNvPr>
          <p:cNvSpPr txBox="1"/>
          <p:nvPr/>
        </p:nvSpPr>
        <p:spPr>
          <a:xfrm>
            <a:off x="7081233" y="294362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(S386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8DB965D-90B8-2AC8-0BCB-FB7CA3F8134F}"/>
              </a:ext>
            </a:extLst>
          </p:cNvPr>
          <p:cNvSpPr txBox="1"/>
          <p:nvPr/>
        </p:nvSpPr>
        <p:spPr>
          <a:xfrm>
            <a:off x="3870549" y="294362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(S396)</a:t>
            </a:r>
          </a:p>
        </p:txBody>
      </p:sp>
      <p:pic>
        <p:nvPicPr>
          <p:cNvPr id="4" name="그림 3" descr="화이트, 블랙, 스케치, 디자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619D7627-9065-BBE9-AC3A-42F853441808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02988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7DE20CC-CFA0-2176-FB13-FC67325D01A8}"/>
              </a:ext>
            </a:extLst>
          </p:cNvPr>
          <p:cNvSpPr txBox="1"/>
          <p:nvPr/>
        </p:nvSpPr>
        <p:spPr>
          <a:xfrm>
            <a:off x="9928990" y="304108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9434" y="1312735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2122" y="1302988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3244" y="1302988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06422737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84BCD86-2C9E-1BC2-2EC1-6787CF6B22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화이트, 블랙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A9DC6765-FE03-32D1-130D-A620517AF22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0573" y="134519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 descr="텍스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1F15ABAA-7D97-F12C-25D3-C4F029D3E879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4519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7141E61-681C-6FAD-B5D7-FB691EBF10AF}"/>
              </a:ext>
            </a:extLst>
          </p:cNvPr>
          <p:cNvSpPr txBox="1"/>
          <p:nvPr/>
        </p:nvSpPr>
        <p:spPr>
          <a:xfrm>
            <a:off x="684560" y="327805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         p-SGK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429A472-F55C-7875-E6D9-87A8B9C65848}"/>
              </a:ext>
            </a:extLst>
          </p:cNvPr>
          <p:cNvSpPr txBox="1"/>
          <p:nvPr/>
        </p:nvSpPr>
        <p:spPr>
          <a:xfrm>
            <a:off x="6870129" y="327805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KT(S473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7141E61-681C-6FAD-B5D7-FB691EBF10AF}"/>
              </a:ext>
            </a:extLst>
          </p:cNvPr>
          <p:cNvSpPr txBox="1"/>
          <p:nvPr/>
        </p:nvSpPr>
        <p:spPr>
          <a:xfrm>
            <a:off x="3812278" y="276223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        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K1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429A472-F55C-7875-E6D9-87A8B9C65848}"/>
              </a:ext>
            </a:extLst>
          </p:cNvPr>
          <p:cNvSpPr txBox="1"/>
          <p:nvPr/>
        </p:nvSpPr>
        <p:spPr>
          <a:xfrm>
            <a:off x="9930516" y="276223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2722" y="134519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0960" y="134519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6337018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13DE081-7305-7AEC-0FE5-35908B3AE9E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서지 억제기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38143856-6C75-3494-E785-8E9D30F5AF0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5615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AE1E7A67-2E6B-364F-406C-55BF531283AF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8726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13336DC-34C9-BE81-FD1D-9B52F0ED5C3F}"/>
              </a:ext>
            </a:extLst>
          </p:cNvPr>
          <p:cNvSpPr txBox="1"/>
          <p:nvPr/>
        </p:nvSpPr>
        <p:spPr>
          <a:xfrm>
            <a:off x="1888282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B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B95F84C-6B29-5A66-A5F9-834963EDD16C}"/>
              </a:ext>
            </a:extLst>
          </p:cNvPr>
          <p:cNvSpPr txBox="1"/>
          <p:nvPr/>
        </p:nvSpPr>
        <p:spPr>
          <a:xfrm>
            <a:off x="5375171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B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(S396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D954AE3-FA56-FF9E-C6E3-B6915A2BC279}"/>
              </a:ext>
            </a:extLst>
          </p:cNvPr>
          <p:cNvSpPr txBox="1"/>
          <p:nvPr/>
        </p:nvSpPr>
        <p:spPr>
          <a:xfrm>
            <a:off x="8861002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B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2504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137001194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13DE081-7305-7AEC-0FE5-35908B3AE9E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그림 19" descr="텍스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AE3F1EF7-CA6E-D431-9645-E750D331FFB2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3483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B95F84C-6B29-5A66-A5F9-834963EDD16C}"/>
              </a:ext>
            </a:extLst>
          </p:cNvPr>
          <p:cNvSpPr txBox="1"/>
          <p:nvPr/>
        </p:nvSpPr>
        <p:spPr>
          <a:xfrm>
            <a:off x="7239140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B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D954AE3-FA56-FF9E-C6E3-B6915A2BC279}"/>
              </a:ext>
            </a:extLst>
          </p:cNvPr>
          <p:cNvSpPr txBox="1"/>
          <p:nvPr/>
        </p:nvSpPr>
        <p:spPr>
          <a:xfrm>
            <a:off x="2621981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B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KT(S473)</a:t>
            </a: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9584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00431838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6C6506-E499-EA85-2A20-D5A7386FFBA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 descr="램프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300ED534-8F1E-7364-A10B-98D32ECCAE8F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9906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658DC14C-3359-FED6-D107-BC44F9DFF93F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3240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A7B4D8E-9A69-1DFB-0207-4E1B5340E6DD}"/>
              </a:ext>
            </a:extLst>
          </p:cNvPr>
          <p:cNvSpPr txBox="1"/>
          <p:nvPr/>
        </p:nvSpPr>
        <p:spPr>
          <a:xfrm>
            <a:off x="1827721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D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2332D46-2CFF-A886-74F1-3C55EBE575C6}"/>
              </a:ext>
            </a:extLst>
          </p:cNvPr>
          <p:cNvSpPr txBox="1"/>
          <p:nvPr/>
        </p:nvSpPr>
        <p:spPr>
          <a:xfrm>
            <a:off x="5389462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D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(S396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ACD80F9-91C5-7CDC-3B03-A3294CED7412}"/>
              </a:ext>
            </a:extLst>
          </p:cNvPr>
          <p:cNvSpPr txBox="1"/>
          <p:nvPr/>
        </p:nvSpPr>
        <p:spPr>
          <a:xfrm>
            <a:off x="8755560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D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6004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424311012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6C6506-E499-EA85-2A20-D5A7386FFBA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 descr="가전용품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DC084E28-C81A-5A8C-BEE4-DDFF7B9D2653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8732" y="1288920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2332D46-2CFF-A886-74F1-3C55EBE575C6}"/>
              </a:ext>
            </a:extLst>
          </p:cNvPr>
          <p:cNvSpPr txBox="1"/>
          <p:nvPr/>
        </p:nvSpPr>
        <p:spPr>
          <a:xfrm>
            <a:off x="7154957" y="271534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D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K1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ACD80F9-91C5-7CDC-3B03-A3294CED7412}"/>
              </a:ext>
            </a:extLst>
          </p:cNvPr>
          <p:cNvSpPr txBox="1"/>
          <p:nvPr/>
        </p:nvSpPr>
        <p:spPr>
          <a:xfrm>
            <a:off x="3177720" y="271534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D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GK1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5401" y="1288920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31309923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78852D-908E-C083-586F-DA1061489D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의료 장비, 바늘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5CB8060B-C19D-9874-E82A-3D62D54C127C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5908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 descr="화이트, 디자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859E7A04-6B08-3595-2471-D216C543560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131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394425B-92DE-473A-FF58-2A274312D74D}"/>
              </a:ext>
            </a:extLst>
          </p:cNvPr>
          <p:cNvSpPr txBox="1"/>
          <p:nvPr/>
        </p:nvSpPr>
        <p:spPr>
          <a:xfrm>
            <a:off x="2018687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F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B93C8D3-714C-933B-A1C2-400E3730A428}"/>
              </a:ext>
            </a:extLst>
          </p:cNvPr>
          <p:cNvSpPr txBox="1"/>
          <p:nvPr/>
        </p:nvSpPr>
        <p:spPr>
          <a:xfrm>
            <a:off x="5386630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F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(S396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43A55F-ADBB-5499-4645-D172790B3BAD}"/>
              </a:ext>
            </a:extLst>
          </p:cNvPr>
          <p:cNvSpPr txBox="1"/>
          <p:nvPr/>
        </p:nvSpPr>
        <p:spPr>
          <a:xfrm>
            <a:off x="8946684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F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7128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152221903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78852D-908E-C083-586F-DA1061489D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그림 15" descr="텍스트, 측정 스틱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6EB2895B-61D9-C84B-D97B-00794E940B4B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7725" y="134519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B93C8D3-714C-933B-A1C2-400E3730A428}"/>
              </a:ext>
            </a:extLst>
          </p:cNvPr>
          <p:cNvSpPr txBox="1"/>
          <p:nvPr/>
        </p:nvSpPr>
        <p:spPr>
          <a:xfrm>
            <a:off x="7440513" y="327805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F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K1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43A55F-ADBB-5499-4645-D172790B3BAD}"/>
              </a:ext>
            </a:extLst>
          </p:cNvPr>
          <p:cNvSpPr txBox="1"/>
          <p:nvPr/>
        </p:nvSpPr>
        <p:spPr>
          <a:xfrm>
            <a:off x="3551724" y="327805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F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GK1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0957" y="134519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161624391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CBCC02-1B5F-372E-12C3-91FD79997CA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 descr="화이트, 흑백, 블랙, 모노크롬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B43C67CD-4203-B481-DCA2-F9EA1B727BCC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0480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F2A70257-A1F0-FD35-6553-9A71EB46F2DC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2514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3F43641-CB36-FE67-1259-E910A8434E4B}"/>
              </a:ext>
            </a:extLst>
          </p:cNvPr>
          <p:cNvSpPr txBox="1"/>
          <p:nvPr/>
        </p:nvSpPr>
        <p:spPr>
          <a:xfrm>
            <a:off x="1852070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163050-CB27-E6CD-0255-A4BC3534F3A9}"/>
              </a:ext>
            </a:extLst>
          </p:cNvPr>
          <p:cNvSpPr txBox="1"/>
          <p:nvPr/>
        </p:nvSpPr>
        <p:spPr>
          <a:xfrm>
            <a:off x="5340036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(S396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CF2AB2-DB01-19CD-F369-9E60512563E5}"/>
              </a:ext>
            </a:extLst>
          </p:cNvPr>
          <p:cNvSpPr txBox="1"/>
          <p:nvPr/>
        </p:nvSpPr>
        <p:spPr>
          <a:xfrm>
            <a:off x="8828002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8446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1212314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80D8211-E54C-D8A1-91BF-6E82BF841FE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B43E342-60F8-B6FE-8902-037226538E6D}"/>
              </a:ext>
            </a:extLst>
          </p:cNvPr>
          <p:cNvSpPr txBox="1"/>
          <p:nvPr/>
        </p:nvSpPr>
        <p:spPr>
          <a:xfrm>
            <a:off x="2202638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H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5ECDB55-AB4D-ED49-4F5F-A3D379C7ADC5}"/>
              </a:ext>
            </a:extLst>
          </p:cNvPr>
          <p:cNvSpPr txBox="1"/>
          <p:nvPr/>
        </p:nvSpPr>
        <p:spPr>
          <a:xfrm>
            <a:off x="5640542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H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 (S396)</a:t>
            </a:r>
          </a:p>
        </p:txBody>
      </p:sp>
      <p:pic>
        <p:nvPicPr>
          <p:cNvPr id="3" name="그림 2" descr="흑백, 모노크롬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8302C1F6-3730-1FFB-29C5-F8CC8F8F2EC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3082" y="1361419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8" name="그림 7" descr="블랙, 화이트, 흑백, 디자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C69A92BE-F055-4444-D5ED-D37861E8B806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0986" y="1361419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5ECDB55-AB4D-ED49-4F5F-A3D379C7ADC5}"/>
              </a:ext>
            </a:extLst>
          </p:cNvPr>
          <p:cNvSpPr txBox="1"/>
          <p:nvPr/>
        </p:nvSpPr>
        <p:spPr>
          <a:xfrm>
            <a:off x="9072038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H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9859" y="1361419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03751658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CBCC02-1B5F-372E-12C3-91FD79997CA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 descr="화이트, 흑백, 스케치, 블랙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B624A928-8DA9-231F-FAC2-F72E52DD260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249" y="131705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8163050-CB27-E6CD-0255-A4BC3534F3A9}"/>
              </a:ext>
            </a:extLst>
          </p:cNvPr>
          <p:cNvSpPr txBox="1"/>
          <p:nvPr/>
        </p:nvSpPr>
        <p:spPr>
          <a:xfrm>
            <a:off x="7168836" y="29967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K1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CF2AB2-DB01-19CD-F369-9E60512563E5}"/>
              </a:ext>
            </a:extLst>
          </p:cNvPr>
          <p:cNvSpPr txBox="1"/>
          <p:nvPr/>
        </p:nvSpPr>
        <p:spPr>
          <a:xfrm>
            <a:off x="3383805" y="29967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GK1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9280" y="131705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165121410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DD296E-E326-1030-A46F-1BDB169C55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D0C9F7B6-E8C7-61CF-0FEC-9BD51B936E9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88920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7638498-6DE2-6E93-F897-939B45CF6EA2}"/>
              </a:ext>
            </a:extLst>
          </p:cNvPr>
          <p:cNvSpPr txBox="1"/>
          <p:nvPr/>
        </p:nvSpPr>
        <p:spPr>
          <a:xfrm>
            <a:off x="644265" y="271534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H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82EF299-6D4F-8CE8-8D17-E3E1435E2AC3}"/>
              </a:ext>
            </a:extLst>
          </p:cNvPr>
          <p:cNvSpPr txBox="1"/>
          <p:nvPr/>
        </p:nvSpPr>
        <p:spPr>
          <a:xfrm>
            <a:off x="3792400" y="271534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H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GK1</a:t>
            </a:r>
          </a:p>
        </p:txBody>
      </p:sp>
      <p:pic>
        <p:nvPicPr>
          <p:cNvPr id="13" name="그림 12" descr="화이트, 램프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BACB4519-CCCA-2235-9CE8-1AC293AC4EEC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2563" y="1288920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7638498-6DE2-6E93-F897-939B45CF6EA2}"/>
              </a:ext>
            </a:extLst>
          </p:cNvPr>
          <p:cNvSpPr txBox="1"/>
          <p:nvPr/>
        </p:nvSpPr>
        <p:spPr>
          <a:xfrm>
            <a:off x="6866872" y="271534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5H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K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82EF299-6D4F-8CE8-8D17-E3E1435E2AC3}"/>
              </a:ext>
            </a:extLst>
          </p:cNvPr>
          <p:cNvSpPr txBox="1"/>
          <p:nvPr/>
        </p:nvSpPr>
        <p:spPr>
          <a:xfrm>
            <a:off x="9930516" y="272521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H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F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7316" y="1288920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0960" y="1289907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69993326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7D48E16-1BCC-59C5-C769-F0F6F696E8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 descr="텍스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78B438AB-AF50-2353-04E5-107D8198CD69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96" y="1225615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1C881B0C-521D-758D-327F-E4C00E0B17E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5809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0F6CEDC-1125-246E-10FE-913C6E5FA192}"/>
              </a:ext>
            </a:extLst>
          </p:cNvPr>
          <p:cNvSpPr txBox="1"/>
          <p:nvPr/>
        </p:nvSpPr>
        <p:spPr>
          <a:xfrm>
            <a:off x="2215365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I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8E2281-D16E-2785-9A8D-0B0AD3EC45F6}"/>
              </a:ext>
            </a:extLst>
          </p:cNvPr>
          <p:cNvSpPr txBox="1"/>
          <p:nvPr/>
        </p:nvSpPr>
        <p:spPr>
          <a:xfrm>
            <a:off x="5665752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I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GK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68E2281-D16E-2785-9A8D-0B0AD3EC45F6}"/>
              </a:ext>
            </a:extLst>
          </p:cNvPr>
          <p:cNvSpPr txBox="1"/>
          <p:nvPr/>
        </p:nvSpPr>
        <p:spPr>
          <a:xfrm>
            <a:off x="9116139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I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K1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6583" y="1225615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55407982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66A7D33-C90D-DCD5-1C10-7B4E0D5B50D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 descr="화이트, 문구용품, 손톱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F8FF72E1-BB08-7E87-9E67-380E24206BBC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7979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" name="그림 3" descr="블랙, 가전용품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F1CB996E-FB0C-44DE-3627-C26037FA077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1508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F62CB32-8A81-43B5-1CCF-EE58ECD1D007}"/>
              </a:ext>
            </a:extLst>
          </p:cNvPr>
          <p:cNvSpPr txBox="1"/>
          <p:nvPr/>
        </p:nvSpPr>
        <p:spPr>
          <a:xfrm>
            <a:off x="2018985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6D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B753E41-B8CE-5DBB-40CA-21D8CA2A0867}"/>
              </a:ext>
            </a:extLst>
          </p:cNvPr>
          <p:cNvSpPr txBox="1"/>
          <p:nvPr/>
        </p:nvSpPr>
        <p:spPr>
          <a:xfrm>
            <a:off x="8336244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6D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</a:p>
        </p:txBody>
      </p:sp>
    </p:spTree>
    <p:extLst>
      <p:ext uri="{BB962C8B-B14F-4D97-AF65-F5344CB8AC3E}">
        <p14:creationId xmlns:p14="http://schemas.microsoft.com/office/powerpoint/2010/main" val="392738838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66A7D33-C90D-DCD5-1C10-7B4E0D5B50D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F62CB32-8A81-43B5-1CCF-EE58ECD1D007}"/>
              </a:ext>
            </a:extLst>
          </p:cNvPr>
          <p:cNvSpPr txBox="1"/>
          <p:nvPr/>
        </p:nvSpPr>
        <p:spPr>
          <a:xfrm>
            <a:off x="2018985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6G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B753E41-B8CE-5DBB-40CA-21D8CA2A0867}"/>
              </a:ext>
            </a:extLst>
          </p:cNvPr>
          <p:cNvSpPr txBox="1"/>
          <p:nvPr/>
        </p:nvSpPr>
        <p:spPr>
          <a:xfrm>
            <a:off x="8336244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6G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F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429" y="1368453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6688" y="1368453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167566488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66A7D33-C90D-DCD5-1C10-7B4E0D5B50D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F62CB32-8A81-43B5-1CCF-EE58ECD1D007}"/>
              </a:ext>
            </a:extLst>
          </p:cNvPr>
          <p:cNvSpPr txBox="1"/>
          <p:nvPr/>
        </p:nvSpPr>
        <p:spPr>
          <a:xfrm>
            <a:off x="2018985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6H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B753E41-B8CE-5DBB-40CA-21D8CA2A0867}"/>
              </a:ext>
            </a:extLst>
          </p:cNvPr>
          <p:cNvSpPr txBox="1"/>
          <p:nvPr/>
        </p:nvSpPr>
        <p:spPr>
          <a:xfrm>
            <a:off x="8336244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6H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K1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429" y="141065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6688" y="141065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135694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168977-395C-98A1-EDDE-1FF66A870D8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EA205C6-FCB3-59B9-BADC-6142D5A35F49}"/>
              </a:ext>
            </a:extLst>
          </p:cNvPr>
          <p:cNvSpPr txBox="1"/>
          <p:nvPr/>
        </p:nvSpPr>
        <p:spPr>
          <a:xfrm>
            <a:off x="1916316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C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B2AFEA4-2366-60E4-8E14-2D4AF9FEA6BC}"/>
              </a:ext>
            </a:extLst>
          </p:cNvPr>
          <p:cNvSpPr txBox="1"/>
          <p:nvPr/>
        </p:nvSpPr>
        <p:spPr>
          <a:xfrm>
            <a:off x="8148873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C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LR10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760" y="1248877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9317" y="1248877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2253068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168977-395C-98A1-EDDE-1FF66A870D8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EA205C6-FCB3-59B9-BADC-6142D5A35F49}"/>
              </a:ext>
            </a:extLst>
          </p:cNvPr>
          <p:cNvSpPr txBox="1"/>
          <p:nvPr/>
        </p:nvSpPr>
        <p:spPr>
          <a:xfrm>
            <a:off x="1916316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E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B2AFEA4-2366-60E4-8E14-2D4AF9FEA6BC}"/>
              </a:ext>
            </a:extLst>
          </p:cNvPr>
          <p:cNvSpPr txBox="1"/>
          <p:nvPr/>
        </p:nvSpPr>
        <p:spPr>
          <a:xfrm>
            <a:off x="8148873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E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2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760" y="116447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9317" y="116447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866989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EF95641-71A9-FA13-0882-5C16C8CBF3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B51F734-C0D3-5CF1-03F8-0A10B61EAD46}"/>
              </a:ext>
            </a:extLst>
          </p:cNvPr>
          <p:cNvSpPr txBox="1"/>
          <p:nvPr/>
        </p:nvSpPr>
        <p:spPr>
          <a:xfrm>
            <a:off x="2458016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H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BA5D0B0-2EAF-0015-A9A2-4E8063C6E371}"/>
              </a:ext>
            </a:extLst>
          </p:cNvPr>
          <p:cNvSpPr txBox="1"/>
          <p:nvPr/>
        </p:nvSpPr>
        <p:spPr>
          <a:xfrm>
            <a:off x="5783829" y="208229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H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 (S386)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41DD9A93-70AD-F073-FCEE-10BB6A8DAF8E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337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5" name="그림 4" descr="텍스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C22AF516-2D3D-114E-1503-14F4F581EE7D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9763" y="1225615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BA5D0B0-2EAF-0015-A9A2-4E8063C6E371}"/>
              </a:ext>
            </a:extLst>
          </p:cNvPr>
          <p:cNvSpPr txBox="1"/>
          <p:nvPr/>
        </p:nvSpPr>
        <p:spPr>
          <a:xfrm>
            <a:off x="9319510" y="208229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2H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4178" y="1225615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103321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6F8309-6EF9-5D40-EABA-57AF69E287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44ACF76-D841-372C-098B-852C72343548}"/>
              </a:ext>
            </a:extLst>
          </p:cNvPr>
          <p:cNvSpPr txBox="1"/>
          <p:nvPr/>
        </p:nvSpPr>
        <p:spPr>
          <a:xfrm>
            <a:off x="2095876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A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32974DE-DB71-BA71-293B-E1ECF3EE259B}"/>
              </a:ext>
            </a:extLst>
          </p:cNvPr>
          <p:cNvSpPr txBox="1"/>
          <p:nvPr/>
        </p:nvSpPr>
        <p:spPr>
          <a:xfrm>
            <a:off x="8351821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A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F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6320" y="1361419"/>
            <a:ext cx="3011040" cy="4135162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2265" y="1361419"/>
            <a:ext cx="3011040" cy="4135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53684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6F8309-6EF9-5D40-EABA-57AF69E287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44ACF76-D841-372C-098B-852C72343548}"/>
              </a:ext>
            </a:extLst>
          </p:cNvPr>
          <p:cNvSpPr txBox="1"/>
          <p:nvPr/>
        </p:nvSpPr>
        <p:spPr>
          <a:xfrm>
            <a:off x="577540" y="35594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B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32974DE-DB71-BA71-293B-E1ECF3EE259B}"/>
              </a:ext>
            </a:extLst>
          </p:cNvPr>
          <p:cNvSpPr txBox="1"/>
          <p:nvPr/>
        </p:nvSpPr>
        <p:spPr>
          <a:xfrm>
            <a:off x="3759052" y="352475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B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 (S386)</a:t>
            </a:r>
          </a:p>
        </p:txBody>
      </p:sp>
      <p:pic>
        <p:nvPicPr>
          <p:cNvPr id="4" name="그림 3" descr="화이트, 디자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F4A152DD-6766-8D11-48BA-E37811945F1A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7332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8" name="그림 7" descr="텍스트이(가) 표시된 사진&#10;&#10;AI 생성 콘텐츠는 정확하지 않을 수 있습니다.">
            <a:extLst>
              <a:ext uri="{FF2B5EF4-FFF2-40B4-BE49-F238E27FC236}">
                <a16:creationId xmlns:a16="http://schemas.microsoft.com/office/drawing/2014/main" id="{7FCD9417-94E8-022F-93B6-8BEB348C9242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9855" y="136986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32974DE-DB71-BA71-293B-E1ECF3EE259B}"/>
              </a:ext>
            </a:extLst>
          </p:cNvPr>
          <p:cNvSpPr txBox="1"/>
          <p:nvPr/>
        </p:nvSpPr>
        <p:spPr>
          <a:xfrm>
            <a:off x="6875198" y="359405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B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2974DE-DB71-BA71-293B-E1ECF3EE259B}"/>
              </a:ext>
            </a:extLst>
          </p:cNvPr>
          <p:cNvSpPr txBox="1"/>
          <p:nvPr/>
        </p:nvSpPr>
        <p:spPr>
          <a:xfrm>
            <a:off x="9930516" y="35594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B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F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5642" y="137332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0960" y="1369861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1138739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DD150E-FE00-7759-CEFF-4F2D7595519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0853019-6B0E-0B9E-0028-904A11875280}"/>
              </a:ext>
            </a:extLst>
          </p:cNvPr>
          <p:cNvSpPr txBox="1"/>
          <p:nvPr/>
        </p:nvSpPr>
        <p:spPr>
          <a:xfrm>
            <a:off x="2267893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E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07DAD0-53A2-EB51-63B7-6115BF8AE5A6}"/>
              </a:ext>
            </a:extLst>
          </p:cNvPr>
          <p:cNvSpPr txBox="1"/>
          <p:nvPr/>
        </p:nvSpPr>
        <p:spPr>
          <a:xfrm>
            <a:off x="5957369" y="211696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E</a:t>
            </a: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F3 (S386)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7889D524-D247-DD47-5BFD-C05B3F7F67CB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337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96722BCA-F109-A8BC-61CE-6A863E69615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7811" y="1229082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607DAD0-53A2-EB51-63B7-6115BF8AE5A6}"/>
              </a:ext>
            </a:extLst>
          </p:cNvPr>
          <p:cNvSpPr txBox="1"/>
          <p:nvPr/>
        </p:nvSpPr>
        <p:spPr>
          <a:xfrm>
            <a:off x="9464913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E</a:t>
            </a: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5357" y="122561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3820887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DD150E-FE00-7759-CEFF-4F2D7595519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0853019-6B0E-0B9E-0028-904A11875280}"/>
              </a:ext>
            </a:extLst>
          </p:cNvPr>
          <p:cNvSpPr txBox="1"/>
          <p:nvPr/>
        </p:nvSpPr>
        <p:spPr>
          <a:xfrm>
            <a:off x="2267893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G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07DAD0-53A2-EB51-63B7-6115BF8AE5A6}"/>
              </a:ext>
            </a:extLst>
          </p:cNvPr>
          <p:cNvSpPr txBox="1"/>
          <p:nvPr/>
        </p:nvSpPr>
        <p:spPr>
          <a:xfrm>
            <a:off x="5957369" y="211696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G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LR4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607DAD0-53A2-EB51-63B7-6115BF8AE5A6}"/>
              </a:ext>
            </a:extLst>
          </p:cNvPr>
          <p:cNvSpPr txBox="1"/>
          <p:nvPr/>
        </p:nvSpPr>
        <p:spPr>
          <a:xfrm>
            <a:off x="9464913" y="208230"/>
            <a:ext cx="1511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3G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LR3</a:t>
            </a:r>
            <a:endParaRPr lang="en-US" altLang="ko-K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337" y="126294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5357" y="126294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7813" y="1262946"/>
            <a:ext cx="3011040" cy="413516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841239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3</TotalTime>
  <Words>164</Words>
  <Application>Microsoft Office PowerPoint</Application>
  <PresentationFormat>와이드스크린</PresentationFormat>
  <Paragraphs>136</Paragraphs>
  <Slides>2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5</vt:i4>
      </vt:variant>
    </vt:vector>
  </HeadingPairs>
  <TitlesOfParts>
    <vt:vector size="29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8625</dc:creator>
  <cp:lastModifiedBy>Un-Hwan Ha</cp:lastModifiedBy>
  <cp:revision>34</cp:revision>
  <dcterms:created xsi:type="dcterms:W3CDTF">2025-07-17T00:47:17Z</dcterms:created>
  <dcterms:modified xsi:type="dcterms:W3CDTF">2025-10-03T01:23:31Z</dcterms:modified>
</cp:coreProperties>
</file>